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FDB12C-B4C3-4105-8588-879C810FFDC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AF88DA-107D-402D-B6D8-7B776DF02B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8B9D5B-4D2D-4A7C-9763-27F809642D0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51467A-7E23-420A-8C1E-AD122676183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20CCD4-7117-47C5-9C72-38AE71B553C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83B5A7-751C-4051-8231-26A874C3C1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5F51B2-95E2-4CC8-BF73-6E8F6EC8B62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27ADCD-1C16-4677-ABC9-F3B75A68AF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FF24B4-2921-4F62-AE24-C2FD4853A3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C4985B-3E5F-479C-BC75-55D2B33BD4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C30DCB-9B7E-46D6-B47B-1707291C56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5BEAA0-BF7C-4ECB-9FE5-6FB0215081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431244-623F-4567-852F-3923979E18F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-1039" r="7032" b="15627"/>
          <a:stretch/>
        </p:blipFill>
        <p:spPr>
          <a:xfrm>
            <a:off x="838080" y="1295280"/>
            <a:ext cx="7315200" cy="504036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838080" y="609480"/>
            <a:ext cx="693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. Related Gene Search for “Interleukin 8”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" descr=""/>
          <p:cNvPicPr/>
          <p:nvPr/>
        </p:nvPicPr>
        <p:blipFill>
          <a:blip r:embed="rId1"/>
          <a:srcRect l="1249" t="0" r="17502" b="6666"/>
          <a:stretch/>
        </p:blipFill>
        <p:spPr>
          <a:xfrm>
            <a:off x="762120" y="990720"/>
            <a:ext cx="7772400" cy="533376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685800" y="380880"/>
            <a:ext cx="693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. Related Term Search for “Inflammatory Response”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" descr=""/>
          <p:cNvPicPr/>
          <p:nvPr/>
        </p:nvPicPr>
        <p:blipFill>
          <a:blip r:embed="rId1"/>
          <a:srcRect l="2501" t="2500" r="15627" b="33336"/>
          <a:stretch/>
        </p:blipFill>
        <p:spPr>
          <a:xfrm>
            <a:off x="457200" y="1066680"/>
            <a:ext cx="8458200" cy="5486400"/>
          </a:xfrm>
          <a:prstGeom prst="rect">
            <a:avLst/>
          </a:prstGeom>
          <a:ln w="0">
            <a:noFill/>
          </a:ln>
        </p:spPr>
      </p:pic>
      <p:pic>
        <p:nvPicPr>
          <p:cNvPr id="46" name="" descr=""/>
          <p:cNvPicPr/>
          <p:nvPr/>
        </p:nvPicPr>
        <p:blipFill>
          <a:blip r:embed="rId2"/>
          <a:srcRect l="2501" t="2500" r="15627" b="33336"/>
          <a:stretch/>
        </p:blipFill>
        <p:spPr>
          <a:xfrm>
            <a:off x="457200" y="1066680"/>
            <a:ext cx="8458200" cy="5486400"/>
          </a:xfrm>
          <a:prstGeom prst="rect">
            <a:avLst/>
          </a:prstGeom>
          <a:ln w="0">
            <a:noFill/>
          </a:ln>
        </p:spPr>
      </p:pic>
      <p:sp>
        <p:nvSpPr>
          <p:cNvPr id="47" name=""/>
          <p:cNvSpPr/>
          <p:nvPr/>
        </p:nvSpPr>
        <p:spPr>
          <a:xfrm>
            <a:off x="609480" y="457200"/>
            <a:ext cx="685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. Related Gene Search for gene group 1 of demo_list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0-17T18:30:08Z</dcterms:created>
  <dc:creator>DaWei Huang</dc:creator>
  <dc:description/>
  <dc:language>en-US</dc:language>
  <cp:lastModifiedBy>DaWei Huang</cp:lastModifiedBy>
  <dcterms:modified xsi:type="dcterms:W3CDTF">2006-10-25T17:40:10Z</dcterms:modified>
  <cp:revision>9</cp:revision>
  <dc:subject/>
  <dc:title>Slide 1</dc:title>
</cp:coreProperties>
</file>